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BF28D-B599-4686-8C34-8AF070DF63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47F07D-4971-463F-A715-8F756750B5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7640B-BFEF-4DD7-A591-D70C4A96F1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C62BA-6566-4F16-9E7C-FBD873150A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B7AF9-0794-4C67-B4BE-A8615E4DD0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4AF76-4328-4209-A686-F4A7B3CFB0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C8028-6332-4CB9-ADA4-3943B3515B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CA075-AC44-4092-B6AC-C6A76AEDBF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C4477-5CB8-4EEC-A8D8-6DD353CAEF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9A8EC-8DF7-4123-9DA6-8D9F0354D8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174C3-B6ED-43B9-8B2A-29AFF1472B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33F6A-F57E-4F1C-9CC9-1D63AB68B8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2DD784-D517-4DB9-819B-D2350C8560C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11280" y="0"/>
          <a:ext cx="8281800" cy="6629400"/>
        </p:xfrm>
        <a:graphic>
          <a:graphicData uri="http://schemas.openxmlformats.org/drawingml/2006/table">
            <a:tbl>
              <a:tblPr/>
              <a:tblGrid>
                <a:gridCol w="1547640"/>
                <a:gridCol w="1036800"/>
                <a:gridCol w="3566880"/>
                <a:gridCol w="2130480"/>
              </a:tblGrid>
              <a:tr h="2178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glutin ge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 seque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AU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nealing temperat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lph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ATAGGGACCAAGCTA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GTTTCTTCATGATTCG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lpha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GATGAACCTCGCTCTC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GCGACGCACTCGAG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lpha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GGCTCAGCTTGAATC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GCCGATTGTACAACAT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ta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ATATAAACCCACAG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TTCCTCTCCTTGCTCG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t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AGAAGTGAAGCAGCT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AGTAGATAGCAGCTT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ta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AGCATAGGAGAGAG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TCCCTCTGTTCCCTC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ta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AGAGCGAAGAAAGCC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TCTCTCTTCCCTCCT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ta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GGAGAAGAAGAGGAAG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CCTTGCTCTTGCTCCCT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ta 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CCACGTCCGCGTAAAC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TCCTCTCATGATATT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mma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CGACAATTCTCTGTATG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ATGATGTTGATGATG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mma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TTTGTTATGGATAG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ACACTCCATAACCT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lt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AATCAGAAGAATCAG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TAAATGCTTTACCAT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lta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ATATTCAGAAGAATCA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TTTACGTTACCTTAGA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lta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TAGCGCCTTCCGATCTTC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CCAGTTCTTCTGATTCTTGG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lta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CAAGAGGATTGTTT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°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TAGATACACTACCA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5T04:46:22Z</dcterms:created>
  <dc:creator>Foley, Rhonda (PI, Floreat)</dc:creator>
  <dc:description/>
  <dc:language>en-US</dc:language>
  <cp:lastModifiedBy>Foley, Rhonda (PI, Floreat)</cp:lastModifiedBy>
  <dcterms:modified xsi:type="dcterms:W3CDTF">2011-03-25T01:59:44Z</dcterms:modified>
  <cp:revision>64</cp:revision>
  <dc:subject/>
  <dc:title>Slide 1</dc:title>
</cp:coreProperties>
</file>